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78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ON2\Users03\v\plzjv\sync\carbon%20starvation%20response\sugar%20assays\time%20series%20noC\data%20timeseries%20recalculat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76640419947507"/>
          <c:y val="5.1400554097404488E-2"/>
          <c:w val="0.71865157480314956"/>
          <c:h val="0.63842811315252257"/>
        </c:manualLayout>
      </c:layout>
      <c:barChart>
        <c:barDir val="col"/>
        <c:grouping val="clustered"/>
        <c:varyColors val="0"/>
        <c:ser>
          <c:idx val="0"/>
          <c:order val="0"/>
          <c:tx>
            <c:v>2 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68:$S$68</c:f>
                <c:numCache>
                  <c:formatCode>General</c:formatCode>
                  <c:ptCount val="8"/>
                  <c:pt idx="0">
                    <c:v>5.5338363487112921E-2</c:v>
                  </c:pt>
                  <c:pt idx="1">
                    <c:v>1.1793913126681872</c:v>
                  </c:pt>
                  <c:pt idx="2">
                    <c:v>0.24951285127320649</c:v>
                  </c:pt>
                  <c:pt idx="3">
                    <c:v>6.94352890055977E-3</c:v>
                  </c:pt>
                  <c:pt idx="4">
                    <c:v>0.26080902592830418</c:v>
                  </c:pt>
                  <c:pt idx="5">
                    <c:v>0.72096950304896956</c:v>
                  </c:pt>
                  <c:pt idx="6">
                    <c:v>3.9729348998333872E-2</c:v>
                  </c:pt>
                  <c:pt idx="7">
                    <c:v>2.0575389875541333E-2</c:v>
                  </c:pt>
                </c:numCache>
              </c:numRef>
            </c:plus>
            <c:minus>
              <c:numRef>
                <c:f>Sheet1!$L$68:$S$68</c:f>
                <c:numCache>
                  <c:formatCode>General</c:formatCode>
                  <c:ptCount val="8"/>
                  <c:pt idx="0">
                    <c:v>5.5338363487112921E-2</c:v>
                  </c:pt>
                  <c:pt idx="1">
                    <c:v>1.1793913126681872</c:v>
                  </c:pt>
                  <c:pt idx="2">
                    <c:v>0.24951285127320649</c:v>
                  </c:pt>
                  <c:pt idx="3">
                    <c:v>6.94352890055977E-3</c:v>
                  </c:pt>
                  <c:pt idx="4">
                    <c:v>0.26080902592830418</c:v>
                  </c:pt>
                  <c:pt idx="5">
                    <c:v>0.72096950304896956</c:v>
                  </c:pt>
                  <c:pt idx="6">
                    <c:v>3.9729348998333872E-2</c:v>
                  </c:pt>
                  <c:pt idx="7">
                    <c:v>2.0575389875541333E-2</c:v>
                  </c:pt>
                </c:numCache>
              </c:numRef>
            </c:minus>
          </c:errBars>
          <c:cat>
            <c:strRef>
              <c:f>Sheet1!$L$62:$R$62</c:f>
              <c:strCache>
                <c:ptCount val="7"/>
                <c:pt idx="0">
                  <c:v>HE-cellulose</c:v>
                </c:pt>
                <c:pt idx="1">
                  <c:v>Xylan</c:v>
                </c:pt>
                <c:pt idx="2">
                  <c:v>Arabinoxylan</c:v>
                </c:pt>
                <c:pt idx="3">
                  <c:v>Xyloglucan</c:v>
                </c:pt>
                <c:pt idx="4">
                  <c:v>Galactomannan</c:v>
                </c:pt>
                <c:pt idx="5">
                  <c:v>Pectin</c:v>
                </c:pt>
                <c:pt idx="6">
                  <c:v>Arabinan</c:v>
                </c:pt>
              </c:strCache>
            </c:strRef>
          </c:cat>
          <c:val>
            <c:numRef>
              <c:f>Sheet1!$L$63:$R$63</c:f>
              <c:numCache>
                <c:formatCode>0.00</c:formatCode>
                <c:ptCount val="7"/>
                <c:pt idx="0">
                  <c:v>5.9495066851851561E-2</c:v>
                </c:pt>
                <c:pt idx="1">
                  <c:v>3.0035434934999006</c:v>
                </c:pt>
                <c:pt idx="2">
                  <c:v>1.2193239450982682</c:v>
                </c:pt>
                <c:pt idx="3">
                  <c:v>-7.9148267218661795E-3</c:v>
                </c:pt>
                <c:pt idx="4">
                  <c:v>3.4229538651216806E-2</c:v>
                </c:pt>
                <c:pt idx="5">
                  <c:v>3.2864085327225192</c:v>
                </c:pt>
                <c:pt idx="6">
                  <c:v>5.9745397106034562E-2</c:v>
                </c:pt>
              </c:numCache>
            </c:numRef>
          </c:val>
        </c:ser>
        <c:ser>
          <c:idx val="1"/>
          <c:order val="1"/>
          <c:tx>
            <c:v>4 h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69:$S$69</c:f>
                <c:numCache>
                  <c:formatCode>General</c:formatCode>
                  <c:ptCount val="8"/>
                  <c:pt idx="0">
                    <c:v>1.1044649155759038E-2</c:v>
                  </c:pt>
                  <c:pt idx="1">
                    <c:v>0.92948701822833668</c:v>
                  </c:pt>
                  <c:pt idx="2">
                    <c:v>0.59508382574352592</c:v>
                  </c:pt>
                  <c:pt idx="3">
                    <c:v>6.7320144028663615E-4</c:v>
                  </c:pt>
                  <c:pt idx="4">
                    <c:v>0.28499925017310201</c:v>
                  </c:pt>
                  <c:pt idx="5">
                    <c:v>0.38885964636601467</c:v>
                  </c:pt>
                  <c:pt idx="6">
                    <c:v>4.9019556996285366E-2</c:v>
                  </c:pt>
                  <c:pt idx="7">
                    <c:v>4.5454261191327255E-2</c:v>
                  </c:pt>
                </c:numCache>
              </c:numRef>
            </c:plus>
            <c:minus>
              <c:numRef>
                <c:f>Sheet1!$L$69:$S$69</c:f>
                <c:numCache>
                  <c:formatCode>General</c:formatCode>
                  <c:ptCount val="8"/>
                  <c:pt idx="0">
                    <c:v>1.1044649155759038E-2</c:v>
                  </c:pt>
                  <c:pt idx="1">
                    <c:v>0.92948701822833668</c:v>
                  </c:pt>
                  <c:pt idx="2">
                    <c:v>0.59508382574352592</c:v>
                  </c:pt>
                  <c:pt idx="3">
                    <c:v>6.7320144028663615E-4</c:v>
                  </c:pt>
                  <c:pt idx="4">
                    <c:v>0.28499925017310201</c:v>
                  </c:pt>
                  <c:pt idx="5">
                    <c:v>0.38885964636601467</c:v>
                  </c:pt>
                  <c:pt idx="6">
                    <c:v>4.9019556996285366E-2</c:v>
                  </c:pt>
                  <c:pt idx="7">
                    <c:v>4.5454261191327255E-2</c:v>
                  </c:pt>
                </c:numCache>
              </c:numRef>
            </c:minus>
          </c:errBars>
          <c:cat>
            <c:strRef>
              <c:f>Sheet1!$L$62:$R$62</c:f>
              <c:strCache>
                <c:ptCount val="7"/>
                <c:pt idx="0">
                  <c:v>HE-cellulose</c:v>
                </c:pt>
                <c:pt idx="1">
                  <c:v>Xylan</c:v>
                </c:pt>
                <c:pt idx="2">
                  <c:v>Arabinoxylan</c:v>
                </c:pt>
                <c:pt idx="3">
                  <c:v>Xyloglucan</c:v>
                </c:pt>
                <c:pt idx="4">
                  <c:v>Galactomannan</c:v>
                </c:pt>
                <c:pt idx="5">
                  <c:v>Pectin</c:v>
                </c:pt>
                <c:pt idx="6">
                  <c:v>Arabinan</c:v>
                </c:pt>
              </c:strCache>
            </c:strRef>
          </c:cat>
          <c:val>
            <c:numRef>
              <c:f>Sheet1!$L$64:$R$64</c:f>
              <c:numCache>
                <c:formatCode>0.00</c:formatCode>
                <c:ptCount val="7"/>
                <c:pt idx="0">
                  <c:v>6.5393049086202873E-2</c:v>
                </c:pt>
                <c:pt idx="1">
                  <c:v>3.5264947151738815</c:v>
                </c:pt>
                <c:pt idx="2">
                  <c:v>1.9797684768849091</c:v>
                </c:pt>
                <c:pt idx="3">
                  <c:v>2.9045836304449263E-2</c:v>
                </c:pt>
                <c:pt idx="4">
                  <c:v>0.10772315137108393</c:v>
                </c:pt>
                <c:pt idx="5">
                  <c:v>3.8870276946281024</c:v>
                </c:pt>
                <c:pt idx="6">
                  <c:v>1.1688419388262181E-2</c:v>
                </c:pt>
              </c:numCache>
            </c:numRef>
          </c:val>
        </c:ser>
        <c:ser>
          <c:idx val="2"/>
          <c:order val="2"/>
          <c:tx>
            <c:v>6 h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70:$S$70</c:f>
                <c:numCache>
                  <c:formatCode>General</c:formatCode>
                  <c:ptCount val="8"/>
                  <c:pt idx="0">
                    <c:v>4.2122242554292148E-3</c:v>
                  </c:pt>
                  <c:pt idx="1">
                    <c:v>1.1393684479183313</c:v>
                  </c:pt>
                  <c:pt idx="2">
                    <c:v>0.82410013459438813</c:v>
                  </c:pt>
                  <c:pt idx="3">
                    <c:v>2.0844452917175987E-2</c:v>
                  </c:pt>
                  <c:pt idx="4">
                    <c:v>8.1626991820331257E-2</c:v>
                  </c:pt>
                  <c:pt idx="5">
                    <c:v>0.49951788210261439</c:v>
                  </c:pt>
                  <c:pt idx="6">
                    <c:v>2.637972136453717E-2</c:v>
                  </c:pt>
                  <c:pt idx="7">
                    <c:v>1.2365705699156756E-2</c:v>
                  </c:pt>
                </c:numCache>
              </c:numRef>
            </c:plus>
            <c:minus>
              <c:numRef>
                <c:f>Sheet1!$L$70:$S$70</c:f>
                <c:numCache>
                  <c:formatCode>General</c:formatCode>
                  <c:ptCount val="8"/>
                  <c:pt idx="0">
                    <c:v>4.2122242554292148E-3</c:v>
                  </c:pt>
                  <c:pt idx="1">
                    <c:v>1.1393684479183313</c:v>
                  </c:pt>
                  <c:pt idx="2">
                    <c:v>0.82410013459438813</c:v>
                  </c:pt>
                  <c:pt idx="3">
                    <c:v>2.0844452917175987E-2</c:v>
                  </c:pt>
                  <c:pt idx="4">
                    <c:v>8.1626991820331257E-2</c:v>
                  </c:pt>
                  <c:pt idx="5">
                    <c:v>0.49951788210261439</c:v>
                  </c:pt>
                  <c:pt idx="6">
                    <c:v>2.637972136453717E-2</c:v>
                  </c:pt>
                  <c:pt idx="7">
                    <c:v>1.2365705699156756E-2</c:v>
                  </c:pt>
                </c:numCache>
              </c:numRef>
            </c:minus>
          </c:errBars>
          <c:cat>
            <c:strRef>
              <c:f>Sheet1!$L$62:$R$62</c:f>
              <c:strCache>
                <c:ptCount val="7"/>
                <c:pt idx="0">
                  <c:v>HE-cellulose</c:v>
                </c:pt>
                <c:pt idx="1">
                  <c:v>Xylan</c:v>
                </c:pt>
                <c:pt idx="2">
                  <c:v>Arabinoxylan</c:v>
                </c:pt>
                <c:pt idx="3">
                  <c:v>Xyloglucan</c:v>
                </c:pt>
                <c:pt idx="4">
                  <c:v>Galactomannan</c:v>
                </c:pt>
                <c:pt idx="5">
                  <c:v>Pectin</c:v>
                </c:pt>
                <c:pt idx="6">
                  <c:v>Arabinan</c:v>
                </c:pt>
              </c:strCache>
            </c:strRef>
          </c:cat>
          <c:val>
            <c:numRef>
              <c:f>Sheet1!$L$65:$R$65</c:f>
              <c:numCache>
                <c:formatCode>0.00</c:formatCode>
                <c:ptCount val="7"/>
                <c:pt idx="0">
                  <c:v>1.8312767743216184E-2</c:v>
                </c:pt>
                <c:pt idx="1">
                  <c:v>3.8629095670267763</c:v>
                </c:pt>
                <c:pt idx="2">
                  <c:v>2.2803828054630833</c:v>
                </c:pt>
                <c:pt idx="3">
                  <c:v>-2.757370199568273E-2</c:v>
                </c:pt>
                <c:pt idx="4">
                  <c:v>-0.10635593160634084</c:v>
                </c:pt>
                <c:pt idx="5">
                  <c:v>3.1030769943876368</c:v>
                </c:pt>
                <c:pt idx="6">
                  <c:v>-1.4362360019037495E-2</c:v>
                </c:pt>
              </c:numCache>
            </c:numRef>
          </c:val>
        </c:ser>
        <c:ser>
          <c:idx val="3"/>
          <c:order val="3"/>
          <c:tx>
            <c:v>9 h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71:$S$71</c:f>
                <c:numCache>
                  <c:formatCode>General</c:formatCode>
                  <c:ptCount val="8"/>
                  <c:pt idx="0">
                    <c:v>1.5458750761356659E-2</c:v>
                  </c:pt>
                  <c:pt idx="1">
                    <c:v>0.86337543842977305</c:v>
                  </c:pt>
                  <c:pt idx="2">
                    <c:v>1.2075677532575499</c:v>
                  </c:pt>
                  <c:pt idx="3">
                    <c:v>7.4635108681283379E-3</c:v>
                  </c:pt>
                  <c:pt idx="4">
                    <c:v>0.13167744206257548</c:v>
                  </c:pt>
                  <c:pt idx="5">
                    <c:v>2.5943584169952322E-2</c:v>
                  </c:pt>
                  <c:pt idx="6">
                    <c:v>3.3602460065314636E-2</c:v>
                  </c:pt>
                  <c:pt idx="7">
                    <c:v>2.1615066737328451E-2</c:v>
                  </c:pt>
                </c:numCache>
              </c:numRef>
            </c:plus>
            <c:minus>
              <c:numRef>
                <c:f>Sheet1!$L$71:$S$71</c:f>
                <c:numCache>
                  <c:formatCode>General</c:formatCode>
                  <c:ptCount val="8"/>
                  <c:pt idx="0">
                    <c:v>1.5458750761356659E-2</c:v>
                  </c:pt>
                  <c:pt idx="1">
                    <c:v>0.86337543842977305</c:v>
                  </c:pt>
                  <c:pt idx="2">
                    <c:v>1.2075677532575499</c:v>
                  </c:pt>
                  <c:pt idx="3">
                    <c:v>7.4635108681283379E-3</c:v>
                  </c:pt>
                  <c:pt idx="4">
                    <c:v>0.13167744206257548</c:v>
                  </c:pt>
                  <c:pt idx="5">
                    <c:v>2.5943584169952322E-2</c:v>
                  </c:pt>
                  <c:pt idx="6">
                    <c:v>3.3602460065314636E-2</c:v>
                  </c:pt>
                  <c:pt idx="7">
                    <c:v>2.1615066737328451E-2</c:v>
                  </c:pt>
                </c:numCache>
              </c:numRef>
            </c:minus>
          </c:errBars>
          <c:cat>
            <c:strRef>
              <c:f>Sheet1!$L$62:$R$62</c:f>
              <c:strCache>
                <c:ptCount val="7"/>
                <c:pt idx="0">
                  <c:v>HE-cellulose</c:v>
                </c:pt>
                <c:pt idx="1">
                  <c:v>Xylan</c:v>
                </c:pt>
                <c:pt idx="2">
                  <c:v>Arabinoxylan</c:v>
                </c:pt>
                <c:pt idx="3">
                  <c:v>Xyloglucan</c:v>
                </c:pt>
                <c:pt idx="4">
                  <c:v>Galactomannan</c:v>
                </c:pt>
                <c:pt idx="5">
                  <c:v>Pectin</c:v>
                </c:pt>
                <c:pt idx="6">
                  <c:v>Arabinan</c:v>
                </c:pt>
              </c:strCache>
            </c:strRef>
          </c:cat>
          <c:val>
            <c:numRef>
              <c:f>Sheet1!$L$66:$R$66</c:f>
              <c:numCache>
                <c:formatCode>0.00</c:formatCode>
                <c:ptCount val="7"/>
                <c:pt idx="0">
                  <c:v>-2.5686008268441682E-2</c:v>
                </c:pt>
                <c:pt idx="1">
                  <c:v>3.6199906079549198</c:v>
                </c:pt>
                <c:pt idx="2">
                  <c:v>3.1147296807975824</c:v>
                </c:pt>
                <c:pt idx="3">
                  <c:v>-2.9675164714554673E-2</c:v>
                </c:pt>
                <c:pt idx="4">
                  <c:v>-2.4101806217722191E-2</c:v>
                </c:pt>
                <c:pt idx="5">
                  <c:v>2.70208286968733</c:v>
                </c:pt>
                <c:pt idx="6">
                  <c:v>9.340945416609672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909440"/>
        <c:axId val="86815872"/>
      </c:barChart>
      <c:catAx>
        <c:axId val="84909440"/>
        <c:scaling>
          <c:orientation val="minMax"/>
        </c:scaling>
        <c:delete val="0"/>
        <c:axPos val="b"/>
        <c:majorTickMark val="out"/>
        <c:minorTickMark val="none"/>
        <c:tickLblPos val="nextTo"/>
        <c:crossAx val="86815872"/>
        <c:crosses val="autoZero"/>
        <c:auto val="1"/>
        <c:lblAlgn val="ctr"/>
        <c:lblOffset val="100"/>
        <c:noMultiLvlLbl val="0"/>
      </c:catAx>
      <c:valAx>
        <c:axId val="86815872"/>
        <c:scaling>
          <c:orientation val="minMax"/>
          <c:max val="5.5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900" b="0">
                    <a:effectLst/>
                  </a:rPr>
                  <a:t>Released reducing carbohydrate ends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900" b="0">
                    <a:effectLst/>
                  </a:rPr>
                  <a:t> (pmol min</a:t>
                </a:r>
                <a:r>
                  <a:rPr lang="en-GB" sz="900" b="0" baseline="30000">
                    <a:effectLst/>
                  </a:rPr>
                  <a:t>-1</a:t>
                </a:r>
                <a:r>
                  <a:rPr lang="en-GB" sz="900" b="0">
                    <a:effectLst/>
                  </a:rPr>
                  <a:t> µl</a:t>
                </a:r>
                <a:r>
                  <a:rPr lang="en-GB" sz="900" b="0" baseline="30000">
                    <a:effectLst/>
                  </a:rPr>
                  <a:t>-1</a:t>
                </a:r>
                <a:r>
                  <a:rPr lang="en-GB" sz="900" b="0">
                    <a:effectLst/>
                  </a:rPr>
                  <a:t>) 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900" b="0"/>
              </a:p>
            </c:rich>
          </c:tx>
          <c:layout>
            <c:manualLayout>
              <c:xMode val="edge"/>
              <c:yMode val="edge"/>
              <c:x val="1.0875109361329833E-2"/>
              <c:y val="4.214129483814523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849094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8769976367062011"/>
          <c:y val="0.1196026538349373"/>
          <c:w val="8.1796756733209172E-2"/>
          <c:h val="0.3348687664041994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1900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316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8651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514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1849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21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6996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3203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855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790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316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36D49-6DB9-4359-8C29-AAA35980ECA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A94B3-540E-4384-B5F8-38502459FD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349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6748542"/>
              </p:ext>
            </p:extLst>
          </p:nvPr>
        </p:nvGraphicFramePr>
        <p:xfrm>
          <a:off x="1475656" y="1556792"/>
          <a:ext cx="5391869" cy="32438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51520" y="2606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mtClean="0"/>
              <a:t>Figure S1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5682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 Munster Jolanda</dc:creator>
  <cp:lastModifiedBy>Van Munster Jolanda</cp:lastModifiedBy>
  <cp:revision>3</cp:revision>
  <dcterms:created xsi:type="dcterms:W3CDTF">2014-03-06T13:12:29Z</dcterms:created>
  <dcterms:modified xsi:type="dcterms:W3CDTF">2014-03-19T22:07:11Z</dcterms:modified>
</cp:coreProperties>
</file>